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68"/>
  </p:normalViewPr>
  <p:slideViewPr>
    <p:cSldViewPr snapToGrid="0" snapToObjects="1">
      <p:cViewPr varScale="1">
        <p:scale>
          <a:sx n="119" d="100"/>
          <a:sy n="119" d="100"/>
        </p:scale>
        <p:origin x="55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C13D0E-D71F-5D75-3F0C-134581D4B1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ACAD406-35B9-216E-D216-A44F268F1D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2D1A3ED-F5E3-6B30-69AE-14F9898996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3FA8F-71BE-004B-B075-1AAB66EEB526}" type="datetimeFigureOut">
              <a:rPr kumimoji="1" lang="zh-CN" altLang="en-US" smtClean="0"/>
              <a:t>2022/7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B8B87BF-019C-2364-CA75-840F0145C2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7AE050B-AACA-2FA8-71FA-D9275A3520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D5ACA-618E-8749-9C3B-73FC0A5C94F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28299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0745448-0978-D37E-6769-79B73721FC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77170EC-3665-273B-563C-D131C10873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D1D8939-1C3C-E9EB-6B05-82CEED67C4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3FA8F-71BE-004B-B075-1AAB66EEB526}" type="datetimeFigureOut">
              <a:rPr kumimoji="1" lang="zh-CN" altLang="en-US" smtClean="0"/>
              <a:t>2022/7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81D18C-BC0E-8BD1-BFDF-EA25F66CEF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52BF6EE-84AE-9AF6-98D4-8562E5C36D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D5ACA-618E-8749-9C3B-73FC0A5C94F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75466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8FB684C-DD7C-6157-2279-8778292632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115E412-16EB-904D-AE2B-1E71977684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DB24E92-B1AF-C33B-CF17-D78CA3E42A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3FA8F-71BE-004B-B075-1AAB66EEB526}" type="datetimeFigureOut">
              <a:rPr kumimoji="1" lang="zh-CN" altLang="en-US" smtClean="0"/>
              <a:t>2022/7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744520F-30FF-D76D-8BD1-E0F2A9ECD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3FC5A0F-00AD-9471-185E-BD8C844E11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D5ACA-618E-8749-9C3B-73FC0A5C94F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8469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551081-7CE8-C201-1501-5F84A985AD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26F733F-9A3D-5B59-F2F3-320A46690D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4BA6BC3-6B87-7E48-6947-825B47705D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3FA8F-71BE-004B-B075-1AAB66EEB526}" type="datetimeFigureOut">
              <a:rPr kumimoji="1" lang="zh-CN" altLang="en-US" smtClean="0"/>
              <a:t>2022/7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4F7B57-E5B8-EEA4-71A8-C4EC71B3F7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5485275-3327-6D7B-9B4A-E349B38849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D5ACA-618E-8749-9C3B-73FC0A5C94F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01846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15434A0-FD8C-A7B6-C27B-0F9EDF3946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0D871DE-A4EF-A991-346E-499E79D86C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662B0A5-E942-C7C2-C39C-38ADA08682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3FA8F-71BE-004B-B075-1AAB66EEB526}" type="datetimeFigureOut">
              <a:rPr kumimoji="1" lang="zh-CN" altLang="en-US" smtClean="0"/>
              <a:t>2022/7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4D45150-722B-46FF-EEF3-AAF4470FA9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71A39EA-1D2B-7CE8-5142-52186BCA42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D5ACA-618E-8749-9C3B-73FC0A5C94F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54397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6D7F7B5-FAF1-1034-A7E1-9A96E8F675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A862A26-F96C-191F-D466-B57ECD13645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6118BD0-5DA4-CEC6-0DBF-4BCA24F9FE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8488BBE-B561-9175-FEFF-FD94E2E0C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3FA8F-71BE-004B-B075-1AAB66EEB526}" type="datetimeFigureOut">
              <a:rPr kumimoji="1" lang="zh-CN" altLang="en-US" smtClean="0"/>
              <a:t>2022/7/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C3A40C3-8F9C-E35A-D0A2-3FF0225D2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A309638-23BC-C69B-6E56-59F30C6EC8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D5ACA-618E-8749-9C3B-73FC0A5C94F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5510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D1CC4B-3E30-FE0E-30A2-1FBF88525E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60A11C2-D5B9-D89D-53B5-3FFEDEB8CF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3501D61-B354-A2D2-01B6-A00005B5EF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160C21C-18AF-81D1-B8F5-7F14A25FFE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C430644-3DB2-D9A3-B243-3035A977CE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B3A3106-E01F-F37D-8539-DB3BB7BF1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3FA8F-71BE-004B-B075-1AAB66EEB526}" type="datetimeFigureOut">
              <a:rPr kumimoji="1" lang="zh-CN" altLang="en-US" smtClean="0"/>
              <a:t>2022/7/6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EA159BC-F8B8-B575-E111-EBBDA75C66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846832F-652E-CC1C-1176-E5AB47C10A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D5ACA-618E-8749-9C3B-73FC0A5C94F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760964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22DF56-02E8-B23F-4B79-BC16D2F076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680078A-20B5-08A4-214E-71D88A5C60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3FA8F-71BE-004B-B075-1AAB66EEB526}" type="datetimeFigureOut">
              <a:rPr kumimoji="1" lang="zh-CN" altLang="en-US" smtClean="0"/>
              <a:t>2022/7/6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E3DC968-2A59-E073-E66C-096EF4A93D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F96748E-467E-06F1-5A08-56EDD40A63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D5ACA-618E-8749-9C3B-73FC0A5C94F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94348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9301C83-DB24-AF56-95BD-6944B20FF9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3FA8F-71BE-004B-B075-1AAB66EEB526}" type="datetimeFigureOut">
              <a:rPr kumimoji="1" lang="zh-CN" altLang="en-US" smtClean="0"/>
              <a:t>2022/7/6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D7EA2BA-7F1D-E251-84FA-AB5009E77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B8DF60C-440B-D146-D46E-24DCD6B388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D5ACA-618E-8749-9C3B-73FC0A5C94F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26460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1DFFDB-E6B0-D900-1F79-5DCAC79CF7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90973F6-5A7D-028D-009C-DD3A7DCB4B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8D5D664-EADC-1511-7766-0ED9339A18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1768BDA-75BB-6AC5-EF4D-BDF7BB841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3FA8F-71BE-004B-B075-1AAB66EEB526}" type="datetimeFigureOut">
              <a:rPr kumimoji="1" lang="zh-CN" altLang="en-US" smtClean="0"/>
              <a:t>2022/7/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29725D2-D688-837D-A375-3EC87CA760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8620B8A-2EC8-10B3-A11B-54673861F7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D5ACA-618E-8749-9C3B-73FC0A5C94F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0257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73ECA4A-07C7-4AF7-7A85-118461B803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02F1075-9572-EC4A-D2F6-B628B35A11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EF01AAA-8E6A-A3A3-6238-6AE4C0C0F7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A2ADC1F-CF10-1CC6-48F7-C395F1FEB3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83FA8F-71BE-004B-B075-1AAB66EEB526}" type="datetimeFigureOut">
              <a:rPr kumimoji="1" lang="zh-CN" altLang="en-US" smtClean="0"/>
              <a:t>2022/7/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6FBCD1C-2DE5-215F-F155-77D0484351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2A18FC6-041A-84B9-0BBA-40208C0FC3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7D5ACA-618E-8749-9C3B-73FC0A5C94F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27937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2D9937A-9949-6AE1-DA55-3566CED1CC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0DC9267-D18C-8F22-8B16-801ADAC92D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9DA0709-B022-97E5-730B-48ED0DE80B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83FA8F-71BE-004B-B075-1AAB66EEB526}" type="datetimeFigureOut">
              <a:rPr kumimoji="1" lang="zh-CN" altLang="en-US" smtClean="0"/>
              <a:t>2022/7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37EE2BE-77EC-2A8B-C271-74468D6ADC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9F1DB56-6981-0FD2-E06A-D5E5E14DF9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7D5ACA-618E-8749-9C3B-73FC0A5C94FC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21038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F6014BC-28FF-DBFC-8B91-03094D35A85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736"/>
          <a:stretch/>
        </p:blipFill>
        <p:spPr>
          <a:xfrm>
            <a:off x="2968487" y="0"/>
            <a:ext cx="5618922" cy="596077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47E969D3-A823-D7E3-F9BD-E0175F898948}"/>
              </a:ext>
            </a:extLst>
          </p:cNvPr>
          <p:cNvSpPr txBox="1"/>
          <p:nvPr/>
        </p:nvSpPr>
        <p:spPr>
          <a:xfrm>
            <a:off x="2259495" y="5761995"/>
            <a:ext cx="767300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</a:t>
            </a:r>
            <a:r>
              <a:rPr kumimoji="1"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eiver operator characteristic curves for predicting non-survival between NLR≤4.86 and NLR&gt;4.86 in anti-melanoma differentiation-associated gene 5 (anti-MDA5) antibody-positive dermatomyositis.</a:t>
            </a:r>
            <a:endParaRPr kumimoji="1"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8813BE9-03D0-1367-F883-CD25066E2964}"/>
              </a:ext>
            </a:extLst>
          </p:cNvPr>
          <p:cNvSpPr txBox="1"/>
          <p:nvPr/>
        </p:nvSpPr>
        <p:spPr>
          <a:xfrm>
            <a:off x="3770244" y="312445"/>
            <a:ext cx="310100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nsitivity=0.74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ficity=0.62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itive Predictive Value=0.43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 predictive value=0.86</a:t>
            </a: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ouden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ex=0.37</a:t>
            </a:r>
          </a:p>
        </p:txBody>
      </p:sp>
    </p:spTree>
    <p:extLst>
      <p:ext uri="{BB962C8B-B14F-4D97-AF65-F5344CB8AC3E}">
        <p14:creationId xmlns:p14="http://schemas.microsoft.com/office/powerpoint/2010/main" val="22618639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49</Words>
  <Application>Microsoft Macintosh PowerPoint</Application>
  <PresentationFormat>宽屏</PresentationFormat>
  <Paragraphs>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t871</dc:creator>
  <cp:lastModifiedBy>xt871</cp:lastModifiedBy>
  <cp:revision>2</cp:revision>
  <dcterms:created xsi:type="dcterms:W3CDTF">2022-06-06T09:35:52Z</dcterms:created>
  <dcterms:modified xsi:type="dcterms:W3CDTF">2022-07-06T07:15:47Z</dcterms:modified>
</cp:coreProperties>
</file>